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27"/>
  </p:normalViewPr>
  <p:slideViewPr>
    <p:cSldViewPr snapToGrid="0" showGuides="1">
      <p:cViewPr varScale="1">
        <p:scale>
          <a:sx n="107" d="100"/>
          <a:sy n="107" d="100"/>
        </p:scale>
        <p:origin x="640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24110C-440D-C548-BB6E-E890B47B5D98}" type="datetimeFigureOut">
              <a:rPr lang="en-US" smtClean="0"/>
              <a:t>1/2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B46035-C6D2-BA42-9D7E-F42AB69B8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588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Table</a:t>
            </a:r>
            <a:r>
              <a:rPr lang="en-US" dirty="0"/>
              <a:t>. Antibodies used for Flow Cytometr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40752B3-E87F-D64F-B64D-FFB23134EDDC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78298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81395-9F03-D144-2BF2-FA63C2B74D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A117CB-E246-C706-8D02-3A329C80CE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1AABA3-6742-D48D-C073-57AB72A26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CB635B-7D84-36EA-E795-9A5461F20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CA7C84-FECF-0E56-FD4F-80632755F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228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41C00-0ED7-13DC-B8AB-E49525243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D0C6FA-AD74-9BF1-83D1-509BAFB539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50D447-3E05-552B-D071-81C30681D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8CBC20-D5A5-6F33-488D-6961EEC49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B193F-2441-75A0-366E-8D5F88533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522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17FC88-3BF2-054B-C0E1-3167B13566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E9EBD1-5218-99CF-A052-C1365EABB6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49FDA-427A-FA42-4835-C53A42CFE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93BE9-5564-5D46-7D06-B961451FC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326CE9-3843-9179-0BFD-CBEDE9929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699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EA9B8-4936-7525-4F3B-89596CE4C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B286C1-EB20-15B2-257E-86B38BD68D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8724C6-903D-63FA-FC49-B483B2024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114CB8-ACAE-616A-6F7C-63BF361C8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F78FB8-567B-FB7A-4BA5-1EA911959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338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06DFE-B8FD-2CC8-1398-4C3BBE10C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E585D7-8B04-7B4E-47AA-D31988509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4AA3E1-7492-A3FE-394D-C8330C56C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FC1B0-E399-AB62-5B65-7B92A0E0B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1BB95F-C765-685D-B613-2DCEF3E8A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375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4C365-0BA2-4564-1C5F-AB0AEDDF5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3C8C6-460F-89FC-0A6E-B443E2E9B4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82B8C0-1EF4-8AD2-8D47-0EA1CEE257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1E7102-DC8B-943F-0A89-639253B56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9BD181-E61D-90C6-A15C-15DB9BF52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4B384-5EA7-0CEE-6465-1F8BF0A19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109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642BE-E051-4C72-FDBD-75E27C2ED6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3C9451-BC27-5AAC-1010-333AE0EF1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118B50-D115-24AB-DB0A-3F17D822B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4CDAE7-C688-4E76-F648-44FEE70EC6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D047ABD-1D59-5C69-E688-A8C299F993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3A4FA0-1E03-1708-B438-38BE15ED5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67606D8-42EF-04F6-D97D-D9F9F8D17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42A3B8F-7EDB-C582-9D81-7F04D2156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338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C7939-CB1D-E376-5280-975C90B3A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3C95E2-191F-88A8-F4EF-F6337F254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86D1F4-E6A4-7EF6-4926-7E9CA80D4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79CEB-9B77-EA55-AF74-C21C16038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2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F0D6FC-892D-EF0C-B42F-98E384605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6B2F9F-E7D4-2EFA-30A0-032EFB558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5BB6A-A805-38E9-737C-274932118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503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67DEE-9ADE-E041-B062-0B9F388D0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8AB096-B3CA-512C-76C6-476CF44726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DA937B-24B2-868F-9D85-33FB617DE3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E0FD91-DB2F-0B23-9407-2F2EB8F7B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B6488-C04F-CE24-A705-CB15DEE5F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0E13A6-20FE-844F-589B-CD5507BF0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16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0277D-0701-DD0B-05DD-2F0089611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0DCDA1-0914-C1B4-E6C6-6123B01BB7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029292-012B-1696-745D-3A51A24A3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F48BA-0FAD-0828-83D1-EE6BB3174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A6907B-4217-DD06-CCE4-1A8AA55F6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700E9C-3741-8A24-C231-69646AFE8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81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BDB369-7F5A-F3F4-AA99-C8B635AB71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878F5A-91DC-7CC7-9BFB-22380A6B0D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06BDF0-AEF0-03D9-F43B-B56B9AC20F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BA1A6-E7C7-E048-9559-E55F200393CD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DA003-8CC9-206D-478E-BF228DB79B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6E3708-9CF4-60B6-4889-3565263B15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CC55A-9DF8-5849-84E8-55DED2453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065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F996AB4-C574-EA29-18B3-E75937A9D19F}"/>
              </a:ext>
            </a:extLst>
          </p:cNvPr>
          <p:cNvGraphicFramePr>
            <a:graphicFrameLocks noGrp="1"/>
          </p:cNvGraphicFramePr>
          <p:nvPr/>
        </p:nvGraphicFramePr>
        <p:xfrm>
          <a:off x="1973183" y="1553601"/>
          <a:ext cx="8507247" cy="4073474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1622633">
                  <a:extLst>
                    <a:ext uri="{9D8B030D-6E8A-4147-A177-3AD203B41FA5}">
                      <a16:colId xmlns:a16="http://schemas.microsoft.com/office/drawing/2014/main" val="4121732425"/>
                    </a:ext>
                  </a:extLst>
                </a:gridCol>
                <a:gridCol w="1161535">
                  <a:extLst>
                    <a:ext uri="{9D8B030D-6E8A-4147-A177-3AD203B41FA5}">
                      <a16:colId xmlns:a16="http://schemas.microsoft.com/office/drawing/2014/main" val="1609012638"/>
                    </a:ext>
                  </a:extLst>
                </a:gridCol>
                <a:gridCol w="1240702">
                  <a:extLst>
                    <a:ext uri="{9D8B030D-6E8A-4147-A177-3AD203B41FA5}">
                      <a16:colId xmlns:a16="http://schemas.microsoft.com/office/drawing/2014/main" val="2012634338"/>
                    </a:ext>
                  </a:extLst>
                </a:gridCol>
                <a:gridCol w="1070012">
                  <a:extLst>
                    <a:ext uri="{9D8B030D-6E8A-4147-A177-3AD203B41FA5}">
                      <a16:colId xmlns:a16="http://schemas.microsoft.com/office/drawing/2014/main" val="43347262"/>
                    </a:ext>
                  </a:extLst>
                </a:gridCol>
                <a:gridCol w="1124465">
                  <a:extLst>
                    <a:ext uri="{9D8B030D-6E8A-4147-A177-3AD203B41FA5}">
                      <a16:colId xmlns:a16="http://schemas.microsoft.com/office/drawing/2014/main" val="2062702997"/>
                    </a:ext>
                  </a:extLst>
                </a:gridCol>
                <a:gridCol w="984883">
                  <a:extLst>
                    <a:ext uri="{9D8B030D-6E8A-4147-A177-3AD203B41FA5}">
                      <a16:colId xmlns:a16="http://schemas.microsoft.com/office/drawing/2014/main" val="3705216917"/>
                    </a:ext>
                  </a:extLst>
                </a:gridCol>
                <a:gridCol w="1303017">
                  <a:extLst>
                    <a:ext uri="{9D8B030D-6E8A-4147-A177-3AD203B41FA5}">
                      <a16:colId xmlns:a16="http://schemas.microsoft.com/office/drawing/2014/main" val="2473545826"/>
                    </a:ext>
                  </a:extLst>
                </a:gridCol>
              </a:tblGrid>
              <a:tr h="46223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arget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lon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at. Number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ompany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Fluorophor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ost Specie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arget Specie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61690323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D90.2 (Thy1.2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3-2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4031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BV60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556130701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D8a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3-6.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073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F7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246604000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D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M4-5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055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BV78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117475799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y6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K1.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28024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F7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592059203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D11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L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64079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D Bioscienc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BV65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amste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305800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y6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A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2764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BV71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246853479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D11b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1/7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1256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E/Dazzle594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/Huma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632051254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HCII (I-A/I-E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5/114.15.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762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F700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081247833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D64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X54-5/7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932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V605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423887060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L1 bet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JTEN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7-7114-8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eBioscie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PC-eFluor700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at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97149898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NF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P6-XT2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0634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olegen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acBlu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at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ous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654219624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ive/Dead Fixable Stai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3495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hermoFishe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qu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257066201"/>
                  </a:ext>
                </a:extLst>
              </a:tr>
              <a:tr h="25679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414848086"/>
                  </a:ext>
                </a:extLst>
              </a:tr>
              <a:tr h="27284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LPS from E. coli O55:B5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288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igma-Aldrich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0299854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10258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Macintosh PowerPoint</Application>
  <PresentationFormat>Widescreen</PresentationFormat>
  <Paragraphs>10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utschman, Clifford</dc:creator>
  <cp:lastModifiedBy>Deutschman, Clifford</cp:lastModifiedBy>
  <cp:revision>1</cp:revision>
  <dcterms:created xsi:type="dcterms:W3CDTF">2023-09-13T15:33:49Z</dcterms:created>
  <dcterms:modified xsi:type="dcterms:W3CDTF">2024-01-27T01:00:19Z</dcterms:modified>
</cp:coreProperties>
</file>